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  <p:sldId id="257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40"/>
  </p:normalViewPr>
  <p:slideViewPr>
    <p:cSldViewPr snapToGrid="0" snapToObjects="1">
      <p:cViewPr>
        <p:scale>
          <a:sx n="43" d="100"/>
          <a:sy n="43" d="100"/>
        </p:scale>
        <p:origin x="3240" y="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7621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2077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8421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3310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119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6638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846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155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763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497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866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F45DD-FAF5-B544-9768-2FF768019A71}" type="datetimeFigureOut">
              <a:rPr lang="de-DE" smtClean="0"/>
              <a:t>09.08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A8637-7D8A-C44A-8C53-D81F606FBB2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201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CE7132A2-F0CC-F64B-B861-90777E98FC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265" y="1117715"/>
            <a:ext cx="10333540" cy="129369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C641CAD-8199-7B41-9F68-2320D4EC40D3}"/>
              </a:ext>
            </a:extLst>
          </p:cNvPr>
          <p:cNvSpPr txBox="1"/>
          <p:nvPr/>
        </p:nvSpPr>
        <p:spPr>
          <a:xfrm>
            <a:off x="836209" y="1400859"/>
            <a:ext cx="505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255FE2-02D4-CD4E-A516-F2F32F2CD8E6}"/>
              </a:ext>
            </a:extLst>
          </p:cNvPr>
          <p:cNvSpPr txBox="1"/>
          <p:nvPr/>
        </p:nvSpPr>
        <p:spPr>
          <a:xfrm>
            <a:off x="6033305" y="1400858"/>
            <a:ext cx="505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CDA98A-9EDC-4142-9B13-52FE367DB69D}"/>
              </a:ext>
            </a:extLst>
          </p:cNvPr>
          <p:cNvSpPr txBox="1"/>
          <p:nvPr/>
        </p:nvSpPr>
        <p:spPr>
          <a:xfrm>
            <a:off x="836209" y="8998752"/>
            <a:ext cx="505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F42177-ABFC-2F47-A3A2-68E44746EA97}"/>
              </a:ext>
            </a:extLst>
          </p:cNvPr>
          <p:cNvSpPr txBox="1"/>
          <p:nvPr/>
        </p:nvSpPr>
        <p:spPr>
          <a:xfrm>
            <a:off x="6033305" y="8998751"/>
            <a:ext cx="505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36DB87-2A71-BA42-ACBE-75DED27B4EE7}"/>
              </a:ext>
            </a:extLst>
          </p:cNvPr>
          <p:cNvSpPr txBox="1"/>
          <p:nvPr/>
        </p:nvSpPr>
        <p:spPr>
          <a:xfrm>
            <a:off x="1130011" y="14333086"/>
            <a:ext cx="99319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</a:t>
            </a:r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C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oponin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(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T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T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orax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uma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T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usion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T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SOFA ≥2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T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fatal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UC: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097957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D0D98BC-E4A5-B542-911B-79D823624B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8087" y="3080946"/>
            <a:ext cx="9775825" cy="1009410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7B223D9-D651-CF46-BB4C-93D94897A695}"/>
              </a:ext>
            </a:extLst>
          </p:cNvPr>
          <p:cNvSpPr txBox="1"/>
          <p:nvPr/>
        </p:nvSpPr>
        <p:spPr>
          <a:xfrm>
            <a:off x="1208087" y="13175054"/>
            <a:ext cx="75393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</a:t>
            </a:r>
            <a:r>
              <a:rPr lang="de-DE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</a:p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C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leukin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(IL-6)/ fatal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rea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0.9.</a:t>
            </a:r>
          </a:p>
        </p:txBody>
      </p:sp>
    </p:spTree>
    <p:extLst>
      <p:ext uri="{BB962C8B-B14F-4D97-AF65-F5344CB8AC3E}">
        <p14:creationId xmlns:p14="http://schemas.microsoft.com/office/powerpoint/2010/main" val="508931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83</Words>
  <Application>Microsoft Macintosh PowerPoint</Application>
  <PresentationFormat>Custom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5</cp:revision>
  <dcterms:created xsi:type="dcterms:W3CDTF">2019-02-09T19:47:52Z</dcterms:created>
  <dcterms:modified xsi:type="dcterms:W3CDTF">2019-08-09T14:46:30Z</dcterms:modified>
</cp:coreProperties>
</file>